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73" r:id="rId2"/>
    <p:sldId id="264" r:id="rId3"/>
    <p:sldId id="272" r:id="rId4"/>
    <p:sldId id="274" r:id="rId5"/>
  </p:sldIdLst>
  <p:sldSz cx="15479713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ex" initials="Alex" lastIdx="1" clrIdx="0">
    <p:extLst>
      <p:ext uri="{19B8F6BF-5375-455C-9EA6-DF929625EA0E}">
        <p15:presenceInfo xmlns:p15="http://schemas.microsoft.com/office/powerpoint/2012/main" userId="Alex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2929"/>
    <a:srgbClr val="FF1919"/>
    <a:srgbClr val="29FA11"/>
    <a:srgbClr val="00000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917" autoAdjust="0"/>
    <p:restoredTop sz="89971" autoAdjust="0"/>
  </p:normalViewPr>
  <p:slideViewPr>
    <p:cSldViewPr snapToGrid="0">
      <p:cViewPr varScale="1">
        <p:scale>
          <a:sx n="101" d="100"/>
          <a:sy n="101" d="100"/>
        </p:scale>
        <p:origin x="132" y="564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5BA754-3C64-4303-AF38-8037AAE31AA9}" type="datetimeFigureOut">
              <a:rPr lang="ko-KR" altLang="en-US" smtClean="0"/>
              <a:t>2018-02-1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-52388" y="1143000"/>
            <a:ext cx="6962776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68B5B9-746C-40BC-8A8D-8D27CE0DD1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60115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-52388" y="1143000"/>
            <a:ext cx="6962776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WNT </a:t>
            </a:r>
            <a:r>
              <a:rPr lang="ko-KR" altLang="en-US" dirty="0" smtClean="0"/>
              <a:t>추가예정</a:t>
            </a:r>
            <a:endParaRPr lang="en-US" altLang="ko-KR" dirty="0" smtClean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68B5B9-746C-40BC-8A8D-8D27CE0DD170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11526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-52388" y="1143000"/>
            <a:ext cx="6962776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Kaplan-Meier Survival Analysis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68B5B9-746C-40BC-8A8D-8D27CE0DD170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59653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934964" y="1122363"/>
            <a:ext cx="11609785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34964" y="3602038"/>
            <a:ext cx="11609785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60591-EEB3-4200-A4A8-6DEE1B8B107E}" type="datetimeFigureOut">
              <a:rPr lang="ko-KR" altLang="en-US" smtClean="0"/>
              <a:t>2018-02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FF25E-F59D-4E3B-A2A4-99048B33F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5425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60591-EEB3-4200-A4A8-6DEE1B8B107E}" type="datetimeFigureOut">
              <a:rPr lang="ko-KR" altLang="en-US" smtClean="0"/>
              <a:t>2018-02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FF25E-F59D-4E3B-A2A4-99048B33F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39756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077670" y="365125"/>
            <a:ext cx="3337813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4230" y="365125"/>
            <a:ext cx="9819943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60591-EEB3-4200-A4A8-6DEE1B8B107E}" type="datetimeFigureOut">
              <a:rPr lang="ko-KR" altLang="en-US" smtClean="0"/>
              <a:t>2018-02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FF25E-F59D-4E3B-A2A4-99048B33F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39801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60591-EEB3-4200-A4A8-6DEE1B8B107E}" type="datetimeFigureOut">
              <a:rPr lang="ko-KR" altLang="en-US" smtClean="0"/>
              <a:t>2018-02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FF25E-F59D-4E3B-A2A4-99048B33F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2101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56168" y="1709739"/>
            <a:ext cx="13351252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56168" y="4589464"/>
            <a:ext cx="13351252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60591-EEB3-4200-A4A8-6DEE1B8B107E}" type="datetimeFigureOut">
              <a:rPr lang="ko-KR" altLang="en-US" smtClean="0"/>
              <a:t>2018-02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FF25E-F59D-4E3B-A2A4-99048B33F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8307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4230" y="1825625"/>
            <a:ext cx="6578878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36605" y="1825625"/>
            <a:ext cx="6578878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60591-EEB3-4200-A4A8-6DEE1B8B107E}" type="datetimeFigureOut">
              <a:rPr lang="ko-KR" altLang="en-US" smtClean="0"/>
              <a:t>2018-02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FF25E-F59D-4E3B-A2A4-99048B33F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9849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6247" y="365126"/>
            <a:ext cx="13351252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6247" y="1681163"/>
            <a:ext cx="654864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66247" y="2505075"/>
            <a:ext cx="6548644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36605" y="1681163"/>
            <a:ext cx="658089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36605" y="2505075"/>
            <a:ext cx="6580894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60591-EEB3-4200-A4A8-6DEE1B8B107E}" type="datetimeFigureOut">
              <a:rPr lang="ko-KR" altLang="en-US" smtClean="0"/>
              <a:t>2018-02-1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FF25E-F59D-4E3B-A2A4-99048B33F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5293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60591-EEB3-4200-A4A8-6DEE1B8B107E}" type="datetimeFigureOut">
              <a:rPr lang="ko-KR" altLang="en-US" smtClean="0"/>
              <a:t>2018-02-1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FF25E-F59D-4E3B-A2A4-99048B33F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6756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60591-EEB3-4200-A4A8-6DEE1B8B107E}" type="datetimeFigureOut">
              <a:rPr lang="ko-KR" altLang="en-US" smtClean="0"/>
              <a:t>2018-02-1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FF25E-F59D-4E3B-A2A4-99048B33F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7347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6247" y="457200"/>
            <a:ext cx="499261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580894" y="987426"/>
            <a:ext cx="7836605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66247" y="2057400"/>
            <a:ext cx="499261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60591-EEB3-4200-A4A8-6DEE1B8B107E}" type="datetimeFigureOut">
              <a:rPr lang="ko-KR" altLang="en-US" smtClean="0"/>
              <a:t>2018-02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FF25E-F59D-4E3B-A2A4-99048B33F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3552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6247" y="457200"/>
            <a:ext cx="4992610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580894" y="987426"/>
            <a:ext cx="7836605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66247" y="2057400"/>
            <a:ext cx="4992610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60591-EEB3-4200-A4A8-6DEE1B8B107E}" type="datetimeFigureOut">
              <a:rPr lang="ko-KR" altLang="en-US" smtClean="0"/>
              <a:t>2018-02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3FF25E-F59D-4E3B-A2A4-99048B33F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4101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4231" y="365126"/>
            <a:ext cx="1335125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4231" y="1825625"/>
            <a:ext cx="13351252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4230" y="6356351"/>
            <a:ext cx="348293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660591-EEB3-4200-A4A8-6DEE1B8B107E}" type="datetimeFigureOut">
              <a:rPr lang="ko-KR" altLang="en-US" smtClean="0"/>
              <a:t>2018-02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27655" y="6356351"/>
            <a:ext cx="522440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32548" y="6356351"/>
            <a:ext cx="348293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3FF25E-F59D-4E3B-A2A4-99048B33FC0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0098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제목 1"/>
          <p:cNvSpPr txBox="1">
            <a:spLocks/>
          </p:cNvSpPr>
          <p:nvPr/>
        </p:nvSpPr>
        <p:spPr>
          <a:xfrm>
            <a:off x="118800" y="118801"/>
            <a:ext cx="2721707" cy="276999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2000" b="1" dirty="0">
                <a:latin typeface="+mn-lt"/>
                <a:ea typeface="Arial Unicode MS" panose="020B0604020202020204" pitchFamily="50" charset="-127"/>
                <a:cs typeface="Arial Unicode MS" panose="020B0604020202020204" pitchFamily="50" charset="-127"/>
              </a:rPr>
              <a:t>Supplementary Figure. </a:t>
            </a:r>
            <a:r>
              <a:rPr lang="en-US" altLang="ko-KR" sz="2000" b="1" dirty="0" smtClean="0">
                <a:latin typeface="+mn-lt"/>
                <a:ea typeface="Arial Unicode MS" panose="020B0604020202020204" pitchFamily="50" charset="-127"/>
                <a:cs typeface="Arial Unicode MS" panose="020B0604020202020204" pitchFamily="50" charset="-127"/>
              </a:rPr>
              <a:t>S1</a:t>
            </a:r>
            <a:endParaRPr lang="ko-KR" altLang="en-US" sz="2000" b="1" dirty="0">
              <a:latin typeface="+mn-lt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grpSp>
        <p:nvGrpSpPr>
          <p:cNvPr id="12" name="그룹 11"/>
          <p:cNvGrpSpPr/>
          <p:nvPr/>
        </p:nvGrpSpPr>
        <p:grpSpPr>
          <a:xfrm>
            <a:off x="3044132" y="2314006"/>
            <a:ext cx="8726632" cy="1903665"/>
            <a:chOff x="872432" y="2131326"/>
            <a:chExt cx="6604002" cy="14406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20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08696" y="2131951"/>
              <a:ext cx="1920000" cy="144000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colorTemperature colorTemp="7200"/>
                      </a14:imgEffect>
                      <a14:imgEffect>
                        <a14:saturation sat="20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56434" y="2131951"/>
              <a:ext cx="1920000" cy="1440000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aturation sat="20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2565" y="2131951"/>
              <a:ext cx="1920000" cy="144000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547769" y="2131326"/>
              <a:ext cx="254750" cy="13974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lang="en-US" altLang="ko-KR" sz="1200" b="1" dirty="0"/>
                <a:t>CD68</a:t>
              </a:r>
              <a:endParaRPr lang="ko-KR" altLang="en-US" sz="120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571638" y="2131326"/>
              <a:ext cx="254750" cy="13974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lang="en-US" altLang="ko-KR" sz="1200" b="1" dirty="0" smtClean="0"/>
                <a:t>CD86</a:t>
              </a:r>
              <a:endParaRPr lang="ko-KR" altLang="en-US" sz="12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601649" y="2131326"/>
              <a:ext cx="314192" cy="139749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algn="r"/>
              <a:r>
                <a:rPr lang="en-US" altLang="ko-KR" sz="1200" b="1" dirty="0" smtClean="0"/>
                <a:t>CD163</a:t>
              </a:r>
              <a:endParaRPr lang="ko-KR" altLang="en-US" sz="12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872432" y="2713451"/>
              <a:ext cx="561469" cy="2445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500" b="1" dirty="0" err="1" smtClean="0">
                  <a:latin typeface="Calibri" panose="020F0502020204030204" pitchFamily="34" charset="0"/>
                </a:rPr>
                <a:t>hTonsil</a:t>
              </a:r>
              <a:endParaRPr lang="ko-KR" altLang="en-US" sz="1500" b="1" dirty="0">
                <a:latin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558904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9118" y="1268272"/>
            <a:ext cx="6372707" cy="4031963"/>
          </a:xfrm>
          <a:prstGeom prst="rect">
            <a:avLst/>
          </a:prstGeom>
        </p:spPr>
      </p:pic>
      <p:sp>
        <p:nvSpPr>
          <p:cNvPr id="6" name="제목 1"/>
          <p:cNvSpPr txBox="1">
            <a:spLocks/>
          </p:cNvSpPr>
          <p:nvPr/>
        </p:nvSpPr>
        <p:spPr>
          <a:xfrm>
            <a:off x="118800" y="118801"/>
            <a:ext cx="2721707" cy="276999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2000" b="1" dirty="0">
                <a:latin typeface="+mn-lt"/>
                <a:ea typeface="Arial Unicode MS" panose="020B0604020202020204" pitchFamily="50" charset="-127"/>
                <a:cs typeface="Arial Unicode MS" panose="020B0604020202020204" pitchFamily="50" charset="-127"/>
              </a:rPr>
              <a:t>Supplementary Figure. </a:t>
            </a:r>
            <a:r>
              <a:rPr lang="en-US" altLang="ko-KR" sz="2000" b="1" dirty="0" smtClean="0">
                <a:latin typeface="+mn-lt"/>
                <a:ea typeface="Arial Unicode MS" panose="020B0604020202020204" pitchFamily="50" charset="-127"/>
                <a:cs typeface="Arial Unicode MS" panose="020B0604020202020204" pitchFamily="50" charset="-127"/>
              </a:rPr>
              <a:t>S2</a:t>
            </a:r>
            <a:endParaRPr lang="ko-KR" altLang="en-US" sz="2000" b="1" dirty="0">
              <a:latin typeface="+mn-lt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306428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87064" y="1678659"/>
            <a:ext cx="3466083" cy="3081600"/>
          </a:xfrm>
          <a:prstGeom prst="rect">
            <a:avLst/>
          </a:prstGeom>
        </p:spPr>
      </p:pic>
      <p:pic>
        <p:nvPicPr>
          <p:cNvPr id="39" name="그림 3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4254" y="1678659"/>
            <a:ext cx="3466083" cy="3081600"/>
          </a:xfrm>
          <a:prstGeom prst="rect">
            <a:avLst/>
          </a:prstGeom>
        </p:spPr>
      </p:pic>
      <p:sp>
        <p:nvSpPr>
          <p:cNvPr id="22" name="제목 1"/>
          <p:cNvSpPr txBox="1">
            <a:spLocks/>
          </p:cNvSpPr>
          <p:nvPr/>
        </p:nvSpPr>
        <p:spPr>
          <a:xfrm>
            <a:off x="464254" y="852668"/>
            <a:ext cx="394330" cy="70907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2000" b="1" dirty="0">
                <a:latin typeface="+mn-lt"/>
                <a:ea typeface="Arial Unicode MS" panose="020B0604020202020204" pitchFamily="50" charset="-127"/>
                <a:cs typeface="Arial Unicode MS" panose="020B0604020202020204" pitchFamily="50" charset="-127"/>
              </a:rPr>
              <a:t>A</a:t>
            </a:r>
            <a:endParaRPr lang="ko-KR" altLang="en-US" sz="2000" b="1" dirty="0">
              <a:latin typeface="+mn-lt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8" name="제목 1"/>
          <p:cNvSpPr txBox="1">
            <a:spLocks/>
          </p:cNvSpPr>
          <p:nvPr/>
        </p:nvSpPr>
        <p:spPr>
          <a:xfrm>
            <a:off x="7987064" y="852668"/>
            <a:ext cx="394330" cy="70907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2000" b="1" dirty="0">
                <a:latin typeface="+mn-lt"/>
                <a:ea typeface="Arial Unicode MS" panose="020B0604020202020204" pitchFamily="50" charset="-127"/>
                <a:cs typeface="Arial Unicode MS" panose="020B0604020202020204" pitchFamily="50" charset="-127"/>
              </a:rPr>
              <a:t>B</a:t>
            </a:r>
            <a:endParaRPr lang="ko-KR" altLang="en-US" sz="2000" b="1" dirty="0">
              <a:latin typeface="+mn-lt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0086365" y="3745875"/>
            <a:ext cx="11224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/>
              <a:t>High M2 Expressers</a:t>
            </a:r>
            <a:endParaRPr lang="ko-KR" altLang="en-US" sz="9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9186310" y="2531450"/>
            <a:ext cx="11015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/>
              <a:t>Low M2 Expressers</a:t>
            </a:r>
            <a:endParaRPr lang="ko-KR" altLang="en-US" sz="9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10368493" y="2205294"/>
            <a:ext cx="5581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i="1" dirty="0"/>
              <a:t>P</a:t>
            </a:r>
            <a:r>
              <a:rPr lang="en-US" altLang="ko-KR" sz="900" b="1" dirty="0"/>
              <a:t> = .037</a:t>
            </a:r>
            <a:endParaRPr lang="ko-KR" altLang="en-US" sz="9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1300983" y="3022884"/>
            <a:ext cx="11224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/>
              <a:t>High M1 Expressers</a:t>
            </a:r>
            <a:endParaRPr lang="ko-KR" altLang="en-US" sz="9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2511636" y="3242668"/>
            <a:ext cx="11015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/>
              <a:t>Low M1 Expressers</a:t>
            </a:r>
            <a:endParaRPr lang="ko-KR" altLang="en-US" sz="9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2758214" y="2178276"/>
            <a:ext cx="5581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i="1" dirty="0"/>
              <a:t>P</a:t>
            </a:r>
            <a:r>
              <a:rPr lang="en-US" altLang="ko-KR" sz="900" b="1" dirty="0"/>
              <a:t> = .199</a:t>
            </a:r>
            <a:endParaRPr lang="ko-KR" altLang="en-US" sz="9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2610779" y="1357201"/>
            <a:ext cx="268721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/>
              <a:t>[Whole patient cohort (N = 45)]</a:t>
            </a:r>
            <a:endParaRPr lang="ko-KR" altLang="en-US" sz="15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9936362" y="1357201"/>
            <a:ext cx="268721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/>
              <a:t>[Whole patient cohort (N = 45)]</a:t>
            </a:r>
            <a:endParaRPr lang="ko-KR" altLang="en-US" sz="1500" b="1" dirty="0"/>
          </a:p>
        </p:txBody>
      </p:sp>
      <p:sp>
        <p:nvSpPr>
          <p:cNvPr id="26" name="제목 1"/>
          <p:cNvSpPr txBox="1">
            <a:spLocks/>
          </p:cNvSpPr>
          <p:nvPr/>
        </p:nvSpPr>
        <p:spPr>
          <a:xfrm>
            <a:off x="118800" y="118801"/>
            <a:ext cx="2721707" cy="276999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2000" b="1" dirty="0">
                <a:latin typeface="+mn-lt"/>
                <a:ea typeface="Arial Unicode MS" panose="020B0604020202020204" pitchFamily="50" charset="-127"/>
                <a:cs typeface="Arial Unicode MS" panose="020B0604020202020204" pitchFamily="50" charset="-127"/>
              </a:rPr>
              <a:t>Supplementary Figure. </a:t>
            </a:r>
            <a:r>
              <a:rPr lang="en-US" altLang="ko-KR" sz="2000" b="1" dirty="0" smtClean="0">
                <a:latin typeface="+mn-lt"/>
                <a:ea typeface="Arial Unicode MS" panose="020B0604020202020204" pitchFamily="50" charset="-127"/>
                <a:cs typeface="Arial Unicode MS" panose="020B0604020202020204" pitchFamily="50" charset="-127"/>
              </a:rPr>
              <a:t>S3</a:t>
            </a:r>
            <a:endParaRPr lang="ko-KR" altLang="en-US" sz="2000" b="1" dirty="0">
              <a:latin typeface="+mn-lt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24" name="그림 2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36396" y="1678659"/>
            <a:ext cx="3466083" cy="3081600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6201409" y="2205294"/>
            <a:ext cx="5581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i="1" dirty="0"/>
              <a:t>P</a:t>
            </a:r>
            <a:r>
              <a:rPr lang="en-US" altLang="ko-KR" sz="900" b="1" dirty="0"/>
              <a:t> = .064</a:t>
            </a:r>
            <a:endParaRPr lang="ko-KR" altLang="en-US" sz="9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5797530" y="2827852"/>
            <a:ext cx="11015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/>
              <a:t>Low M1 Expressers</a:t>
            </a:r>
            <a:endParaRPr lang="ko-KR" altLang="en-US" sz="9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5364398" y="3560843"/>
            <a:ext cx="11224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/>
              <a:t>High M1 Expressers</a:t>
            </a:r>
            <a:endParaRPr lang="ko-KR" altLang="en-US" sz="900" b="1" dirty="0"/>
          </a:p>
        </p:txBody>
      </p:sp>
      <p:pic>
        <p:nvPicPr>
          <p:cNvPr id="42" name="그림 4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453147" y="1674621"/>
            <a:ext cx="3466083" cy="3081600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13336368" y="3424941"/>
            <a:ext cx="11224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/>
              <a:t>High M2 Expressers</a:t>
            </a:r>
            <a:endParaRPr lang="ko-KR" altLang="en-US" sz="9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12215510" y="1958750"/>
            <a:ext cx="11015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/>
              <a:t>Low M2 Expressers</a:t>
            </a:r>
            <a:endParaRPr lang="ko-KR" altLang="en-US" sz="9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13660381" y="2179726"/>
            <a:ext cx="5581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i="1" dirty="0"/>
              <a:t>P</a:t>
            </a:r>
            <a:r>
              <a:rPr lang="en-US" altLang="ko-KR" sz="900" b="1" dirty="0"/>
              <a:t> = .494</a:t>
            </a:r>
            <a:endParaRPr lang="ko-KR" altLang="en-US" sz="900" b="1" dirty="0"/>
          </a:p>
        </p:txBody>
      </p:sp>
    </p:spTree>
    <p:extLst>
      <p:ext uri="{BB962C8B-B14F-4D97-AF65-F5344CB8AC3E}">
        <p14:creationId xmlns:p14="http://schemas.microsoft.com/office/powerpoint/2010/main" val="34998804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그림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615" y="1292874"/>
            <a:ext cx="7108710" cy="3600000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6845" y="1292874"/>
            <a:ext cx="7108710" cy="3600000"/>
          </a:xfrm>
          <a:prstGeom prst="rect">
            <a:avLst/>
          </a:prstGeom>
        </p:spPr>
      </p:pic>
      <p:sp>
        <p:nvSpPr>
          <p:cNvPr id="17" name="제목 1"/>
          <p:cNvSpPr txBox="1">
            <a:spLocks/>
          </p:cNvSpPr>
          <p:nvPr/>
        </p:nvSpPr>
        <p:spPr>
          <a:xfrm>
            <a:off x="118800" y="118801"/>
            <a:ext cx="2721707" cy="276999"/>
          </a:xfrm>
          <a:prstGeom prst="rect">
            <a:avLst/>
          </a:prstGeom>
        </p:spPr>
        <p:txBody>
          <a:bodyPr vert="horz" wrap="none" lIns="0" tIns="0" rIns="0" bIns="0" rtlCol="0" anchor="t" anchorCtr="0">
            <a:sp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2000" b="1" dirty="0">
                <a:latin typeface="+mn-lt"/>
                <a:ea typeface="Arial Unicode MS" panose="020B0604020202020204" pitchFamily="50" charset="-127"/>
                <a:cs typeface="Arial Unicode MS" panose="020B0604020202020204" pitchFamily="50" charset="-127"/>
              </a:rPr>
              <a:t>Supplementary Figure. </a:t>
            </a:r>
            <a:r>
              <a:rPr lang="en-US" altLang="ko-KR" sz="2000" b="1" dirty="0" smtClean="0">
                <a:latin typeface="+mn-lt"/>
                <a:ea typeface="Arial Unicode MS" panose="020B0604020202020204" pitchFamily="50" charset="-127"/>
                <a:cs typeface="Arial Unicode MS" panose="020B0604020202020204" pitchFamily="50" charset="-127"/>
              </a:rPr>
              <a:t>S4</a:t>
            </a:r>
            <a:endParaRPr lang="ko-KR" altLang="en-US" sz="2000" b="1" dirty="0">
              <a:latin typeface="+mn-lt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006208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58</TotalTime>
  <Words>87</Words>
  <Application>Microsoft Office PowerPoint</Application>
  <PresentationFormat>사용자 지정</PresentationFormat>
  <Paragraphs>28</Paragraphs>
  <Slides>4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0" baseType="lpstr">
      <vt:lpstr>Arial Unicode MS</vt:lpstr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1 Activated Macrophage Recruitment Correlates with Worse Outcome in SHH Medulloblastomas</dc:title>
  <dc:creator>Alex</dc:creator>
  <cp:lastModifiedBy>Alex</cp:lastModifiedBy>
  <cp:revision>183</cp:revision>
  <dcterms:created xsi:type="dcterms:W3CDTF">2017-03-27T00:41:57Z</dcterms:created>
  <dcterms:modified xsi:type="dcterms:W3CDTF">2018-02-13T01:25:37Z</dcterms:modified>
</cp:coreProperties>
</file>